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7F893E-5735-4D69-A925-B038428D6F7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AE16E-F5FD-4F6D-A9BC-CE82963C56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56403E-6E84-432D-990D-2AEB591E7F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FA32B2-37EC-49B5-83A5-B1DAC850AD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1F8C2C-655E-49B1-B24E-FB4A4F6A4D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03EB73-DF26-4C06-B636-CF363D6479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2E6668-4D39-45C5-B809-2B845EBCD4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27D3DB-0DCF-4A52-BDE3-ACB58F6E61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3CA539-C0D8-4BC2-8475-A11BAAE8FD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AF0C9C-7472-446E-8B56-47D4FF1254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B75171-F4DF-41DC-9493-675BAA5FA6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D336F5-2258-4AD5-A60A-AA382254D0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223640-642E-4BFF-A089-A4A9EAE7EFA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Arabidopsis HSP101"/>
          <p:cNvPicPr/>
          <p:nvPr/>
        </p:nvPicPr>
        <p:blipFill>
          <a:blip r:embed="rId1"/>
          <a:stretch/>
        </p:blipFill>
        <p:spPr>
          <a:xfrm>
            <a:off x="1523880" y="239760"/>
            <a:ext cx="1397160" cy="182412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3"/>
          <p:cNvSpPr/>
          <p:nvPr/>
        </p:nvSpPr>
        <p:spPr>
          <a:xfrm>
            <a:off x="449280" y="2381400"/>
            <a:ext cx="18396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4"/>
          <p:cNvSpPr/>
          <p:nvPr/>
        </p:nvSpPr>
        <p:spPr>
          <a:xfrm>
            <a:off x="449280" y="2381400"/>
            <a:ext cx="18396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5" descr="ClpB-TASSER"/>
          <p:cNvPicPr/>
          <p:nvPr/>
        </p:nvPicPr>
        <p:blipFill>
          <a:blip r:embed="rId2"/>
          <a:srcRect l="0" t="0" r="0" b="15654"/>
          <a:stretch/>
        </p:blipFill>
        <p:spPr>
          <a:xfrm>
            <a:off x="2946240" y="182520"/>
            <a:ext cx="5270760" cy="1812960"/>
          </a:xfrm>
          <a:prstGeom prst="rect">
            <a:avLst/>
          </a:prstGeom>
          <a:ln w="0">
            <a:noFill/>
          </a:ln>
        </p:spPr>
      </p:pic>
      <p:sp>
        <p:nvSpPr>
          <p:cNvPr id="45" name="Rectangle 6"/>
          <p:cNvSpPr/>
          <p:nvPr/>
        </p:nvSpPr>
        <p:spPr>
          <a:xfrm>
            <a:off x="449280" y="2381400"/>
            <a:ext cx="18396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7"/>
          <p:cNvSpPr/>
          <p:nvPr/>
        </p:nvSpPr>
        <p:spPr>
          <a:xfrm>
            <a:off x="449280" y="2381400"/>
            <a:ext cx="18396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8" descr="ClpB-binding sites"/>
          <p:cNvPicPr/>
          <p:nvPr/>
        </p:nvPicPr>
        <p:blipFill>
          <a:blip r:embed="rId3"/>
          <a:srcRect l="0" t="0" r="0" b="14079"/>
          <a:stretch/>
        </p:blipFill>
        <p:spPr>
          <a:xfrm>
            <a:off x="1727280" y="2514600"/>
            <a:ext cx="6324480" cy="2209680"/>
          </a:xfrm>
          <a:prstGeom prst="rect">
            <a:avLst/>
          </a:prstGeom>
          <a:ln w="0">
            <a:noFill/>
          </a:ln>
        </p:spPr>
      </p:pic>
      <p:sp>
        <p:nvSpPr>
          <p:cNvPr id="48" name="Text Box 9"/>
          <p:cNvSpPr/>
          <p:nvPr/>
        </p:nvSpPr>
        <p:spPr>
          <a:xfrm>
            <a:off x="711360" y="5145120"/>
            <a:ext cx="78231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itional file 4. A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tructure of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A. thaliana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pB monomer.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B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Monomeric structures of OsClpB proteins as predicted at I-TASSER server. Structures with the highest C-score were chosen for all the proteins.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Predicted binding sites present in the rice ClpB proteins. The predicted binding sites are shown in green spheres while N- and C-terminus in the model are marked by blue and red spheres, respectivel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0"/>
          <p:cNvSpPr/>
          <p:nvPr/>
        </p:nvSpPr>
        <p:spPr>
          <a:xfrm>
            <a:off x="896400" y="152280"/>
            <a:ext cx="3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1"/>
          <p:cNvSpPr/>
          <p:nvPr/>
        </p:nvSpPr>
        <p:spPr>
          <a:xfrm>
            <a:off x="899280" y="1782720"/>
            <a:ext cx="363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1"/>
          <p:cNvSpPr/>
          <p:nvPr/>
        </p:nvSpPr>
        <p:spPr>
          <a:xfrm>
            <a:off x="3331080" y="1981080"/>
            <a:ext cx="100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OsClpB-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2"/>
          <p:cNvSpPr/>
          <p:nvPr/>
        </p:nvSpPr>
        <p:spPr>
          <a:xfrm>
            <a:off x="4958640" y="1981080"/>
            <a:ext cx="109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OsClpB-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3"/>
          <p:cNvSpPr/>
          <p:nvPr/>
        </p:nvSpPr>
        <p:spPr>
          <a:xfrm>
            <a:off x="6744240" y="1981080"/>
            <a:ext cx="118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OsClpB-cy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4"/>
          <p:cNvSpPr/>
          <p:nvPr/>
        </p:nvSpPr>
        <p:spPr>
          <a:xfrm>
            <a:off x="2215080" y="4689360"/>
            <a:ext cx="100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OsClpB-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5"/>
          <p:cNvSpPr/>
          <p:nvPr/>
        </p:nvSpPr>
        <p:spPr>
          <a:xfrm>
            <a:off x="4275720" y="4689360"/>
            <a:ext cx="109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OsClpB-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6"/>
          <p:cNvSpPr/>
          <p:nvPr/>
        </p:nvSpPr>
        <p:spPr>
          <a:xfrm>
            <a:off x="6350400" y="4689360"/>
            <a:ext cx="118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OsClpB-cy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23T16:36:37Z</dcterms:created>
  <dc:creator>Aman</dc:creator>
  <dc:description/>
  <dc:language>en-US</dc:language>
  <cp:lastModifiedBy>Aman</cp:lastModifiedBy>
  <dcterms:modified xsi:type="dcterms:W3CDTF">2009-09-23T16:59:20Z</dcterms:modified>
  <cp:revision>3</cp:revision>
  <dc:subject/>
  <dc:title>Slide 1</dc:title>
</cp:coreProperties>
</file>